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10799763" cy="125999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6720" y="1142640"/>
            <a:ext cx="264456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524"/>
              </a:spcBef>
              <a:buNone/>
              <a:tabLst>
                <a:tab algn="l" pos="0"/>
                <a:tab algn="l" pos="1130400"/>
                <a:tab algn="l" pos="2260440"/>
                <a:tab algn="l" pos="3390840"/>
                <a:tab algn="l" pos="4521240"/>
                <a:tab algn="l" pos="5651640"/>
                <a:tab algn="l" pos="6781680"/>
                <a:tab algn="l" pos="7912080"/>
                <a:tab algn="l" pos="9042480"/>
                <a:tab algn="l" pos="101728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fld id="{9541578E-6DD1-46DF-8C8C-FB569703CFC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ldImg"/>
          </p:nvPr>
        </p:nvSpPr>
        <p:spPr>
          <a:xfrm>
            <a:off x="2106720" y="1143000"/>
            <a:ext cx="2644560" cy="3086280"/>
          </a:xfrm>
          <a:prstGeom prst="rect">
            <a:avLst/>
          </a:prstGeom>
          <a:ln w="0">
            <a:noFill/>
          </a:ln>
        </p:spPr>
      </p:sp>
      <p:sp>
        <p:nvSpPr>
          <p:cNvPr id="23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524"/>
              </a:spcBef>
              <a:buNone/>
              <a:tabLst>
                <a:tab algn="l" pos="0"/>
                <a:tab algn="l" pos="1130400"/>
                <a:tab algn="l" pos="2260440"/>
                <a:tab algn="l" pos="3390840"/>
                <a:tab algn="l" pos="4521240"/>
                <a:tab algn="l" pos="5651640"/>
                <a:tab algn="l" pos="6781680"/>
                <a:tab algn="l" pos="7912080"/>
                <a:tab algn="l" pos="9042480"/>
                <a:tab algn="l" pos="1017288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fld id="{F5CAC429-D6E1-494A-AE85-86E02BCE27D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5F0BD-2FEC-4404-907A-3BC3203E5C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9720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9280" y="7283520"/>
            <a:ext cx="9720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EE957-B9B3-4630-B8C7-5065BA8537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20240" y="29401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9280" y="72835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20240" y="72835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22F449-C78A-44DA-B51C-8F6992085F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312984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26080" y="2940120"/>
            <a:ext cx="312984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12880" y="2940120"/>
            <a:ext cx="312984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9280" y="7283520"/>
            <a:ext cx="312984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26080" y="7283520"/>
            <a:ext cx="312984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12880" y="7283520"/>
            <a:ext cx="312984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480C6-47EC-493B-8B7A-8434C4750C5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9280" y="2940120"/>
            <a:ext cx="9720360" cy="831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CB542C-C469-4153-9A1D-CB5BDCD793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9720360" cy="831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20D71-8892-4CD4-89D8-D56BE0CFB6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4743360" cy="831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20240" y="2940120"/>
            <a:ext cx="4743360" cy="831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2BEDF-69EE-42F2-B724-C6FFBAB603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3675D-55C9-4601-BB28-5DEE6997C4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9280" y="504720"/>
            <a:ext cx="9720360" cy="973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9B925-BEAF-4DE4-8701-9F71B194F8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20240" y="2940120"/>
            <a:ext cx="4743360" cy="831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9280" y="72835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9BA89-875B-40B9-9136-73AD593D94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4743360" cy="831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20240" y="29401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20240" y="72835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A1D35-F99F-4A0B-BB53-54FEADCF18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9280" y="29401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20240" y="2940120"/>
            <a:ext cx="4743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9280" y="7283520"/>
            <a:ext cx="9720360" cy="396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393C5-2252-4B07-B498-A9D452A51C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9280" y="504720"/>
            <a:ext cx="9720360" cy="21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9280" y="2940120"/>
            <a:ext cx="9720360" cy="831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9280" y="11677320"/>
            <a:ext cx="2521080" cy="671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688920" y="11677320"/>
            <a:ext cx="3421080" cy="671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38560" y="11677320"/>
            <a:ext cx="2521080" cy="671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fld id="{47B1A659-17BA-4B1F-B620-059C5A7D4F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4.png"/><Relationship Id="rId7" Type="http://schemas.openxmlformats.org/officeDocument/2006/relationships/image" Target="../media/image1.png"/><Relationship Id="rId8" Type="http://schemas.openxmlformats.org/officeDocument/2006/relationships/image" Target="../media/image3.png"/><Relationship Id="rId9" Type="http://schemas.openxmlformats.org/officeDocument/2006/relationships/image" Target="../media/image1.png"/><Relationship Id="rId10" Type="http://schemas.openxmlformats.org/officeDocument/2006/relationships/image" Target="../media/image5.png"/><Relationship Id="rId11" Type="http://schemas.openxmlformats.org/officeDocument/2006/relationships/image" Target="../media/image4.png"/><Relationship Id="rId12" Type="http://schemas.openxmlformats.org/officeDocument/2006/relationships/slideLayout" Target="../slideLayouts/slideLayout1.xml"/><Relationship Id="rId1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5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1.png"/><Relationship Id="rId7" Type="http://schemas.openxmlformats.org/officeDocument/2006/relationships/image" Target="../media/image4.png"/><Relationship Id="rId8" Type="http://schemas.openxmlformats.org/officeDocument/2006/relationships/image" Target="../media/image1.png"/><Relationship Id="rId9" Type="http://schemas.openxmlformats.org/officeDocument/2006/relationships/image" Target="../media/image2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2.png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4.png"/><Relationship Id="rId5" Type="http://schemas.openxmlformats.org/officeDocument/2006/relationships/image" Target="../media/image3.png"/><Relationship Id="rId6" Type="http://schemas.openxmlformats.org/officeDocument/2006/relationships/image" Target="../media/image1.pn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image" Target="../media/image5.png"/><Relationship Id="rId10" Type="http://schemas.openxmlformats.org/officeDocument/2006/relationships/image" Target="../media/image4.png"/><Relationship Id="rId11" Type="http://schemas.openxmlformats.org/officeDocument/2006/relationships/image" Target="../media/image5.png"/><Relationship Id="rId12" Type="http://schemas.openxmlformats.org/officeDocument/2006/relationships/image" Target="../media/image4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3182760" y="7993080"/>
            <a:ext cx="1060560" cy="5508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"/>
          <p:cNvPicPr/>
          <p:nvPr/>
        </p:nvPicPr>
        <p:blipFill>
          <a:blip r:embed="rId2"/>
          <a:stretch/>
        </p:blipFill>
        <p:spPr>
          <a:xfrm>
            <a:off x="3300480" y="7399440"/>
            <a:ext cx="1060560" cy="65232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19"/>
          <p:cNvSpPr/>
          <p:nvPr/>
        </p:nvSpPr>
        <p:spPr>
          <a:xfrm>
            <a:off x="7954920" y="3686040"/>
            <a:ext cx="23115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white Dahomey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tock male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(repeated x 4 generation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6" descr=""/>
          <p:cNvPicPr/>
          <p:nvPr/>
        </p:nvPicPr>
        <p:blipFill>
          <a:blip r:embed="rId3"/>
          <a:stretch/>
        </p:blipFill>
        <p:spPr>
          <a:xfrm>
            <a:off x="3227400" y="5057640"/>
            <a:ext cx="1063440" cy="64944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" descr=""/>
          <p:cNvPicPr/>
          <p:nvPr/>
        </p:nvPicPr>
        <p:blipFill>
          <a:blip r:embed="rId4"/>
          <a:stretch/>
        </p:blipFill>
        <p:spPr>
          <a:xfrm>
            <a:off x="5199120" y="5452920"/>
            <a:ext cx="1055520" cy="5540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0" descr=""/>
          <p:cNvPicPr/>
          <p:nvPr/>
        </p:nvPicPr>
        <p:blipFill>
          <a:blip r:embed="rId5"/>
          <a:stretch/>
        </p:blipFill>
        <p:spPr>
          <a:xfrm>
            <a:off x="3228840" y="2658960"/>
            <a:ext cx="1054080" cy="6350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1" descr=""/>
          <p:cNvPicPr/>
          <p:nvPr/>
        </p:nvPicPr>
        <p:blipFill>
          <a:blip r:embed="rId6"/>
          <a:stretch/>
        </p:blipFill>
        <p:spPr>
          <a:xfrm>
            <a:off x="5122800" y="3774960"/>
            <a:ext cx="1057320" cy="5540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4" descr=""/>
          <p:cNvPicPr/>
          <p:nvPr/>
        </p:nvPicPr>
        <p:blipFill>
          <a:blip r:embed="rId7"/>
          <a:stretch/>
        </p:blipFill>
        <p:spPr>
          <a:xfrm>
            <a:off x="5119560" y="2700360"/>
            <a:ext cx="1060560" cy="5508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6" descr=""/>
          <p:cNvPicPr/>
          <p:nvPr/>
        </p:nvPicPr>
        <p:blipFill>
          <a:blip r:embed="rId8"/>
          <a:stretch/>
        </p:blipFill>
        <p:spPr>
          <a:xfrm>
            <a:off x="3230640" y="3727440"/>
            <a:ext cx="1063440" cy="649440"/>
          </a:xfrm>
          <a:prstGeom prst="rect">
            <a:avLst/>
          </a:prstGeom>
          <a:ln w="0">
            <a:noFill/>
          </a:ln>
        </p:spPr>
      </p:pic>
      <p:sp>
        <p:nvSpPr>
          <p:cNvPr id="57" name="TextBox 34"/>
          <p:cNvSpPr/>
          <p:nvPr/>
        </p:nvSpPr>
        <p:spPr>
          <a:xfrm>
            <a:off x="2106720" y="2682720"/>
            <a:ext cx="947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r>
              <a:rPr b="0" lang="en-US" sz="1200" spc="-1" strike="noStrike" u="sng" baseline="30000">
                <a:solidFill>
                  <a:srgbClr val="000000"/>
                </a:solidFill>
                <a:uFillTx/>
                <a:latin typeface="Arial"/>
              </a:rPr>
              <a:t>Dahome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Dahome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35"/>
          <p:cNvSpPr/>
          <p:nvPr/>
        </p:nvSpPr>
        <p:spPr>
          <a:xfrm>
            <a:off x="6264720" y="274464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36"/>
          <p:cNvSpPr/>
          <p:nvPr/>
        </p:nvSpPr>
        <p:spPr>
          <a:xfrm>
            <a:off x="4553640" y="27874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0" name="Straight Arrow Connector 37"/>
          <p:cNvCxnSpPr/>
          <p:nvPr/>
        </p:nvCxnSpPr>
        <p:spPr>
          <a:xfrm flipH="1">
            <a:off x="4003200" y="3211560"/>
            <a:ext cx="548640" cy="475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61" name="Rectangle 38"/>
          <p:cNvSpPr/>
          <p:nvPr/>
        </p:nvSpPr>
        <p:spPr>
          <a:xfrm>
            <a:off x="4553640" y="38685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39"/>
          <p:cNvSpPr/>
          <p:nvPr/>
        </p:nvSpPr>
        <p:spPr>
          <a:xfrm>
            <a:off x="3267000" y="2046240"/>
            <a:ext cx="89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0"/>
          <p:cNvSpPr/>
          <p:nvPr/>
        </p:nvSpPr>
        <p:spPr>
          <a:xfrm>
            <a:off x="5293440" y="2046240"/>
            <a:ext cx="67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4" name="Straight Arrow Connector 42"/>
          <p:cNvCxnSpPr/>
          <p:nvPr/>
        </p:nvCxnSpPr>
        <p:spPr>
          <a:xfrm flipH="1">
            <a:off x="3998160" y="4346640"/>
            <a:ext cx="548280" cy="475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65" name="Rectangle 43"/>
          <p:cNvSpPr/>
          <p:nvPr/>
        </p:nvSpPr>
        <p:spPr>
          <a:xfrm>
            <a:off x="4587120" y="52531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4" descr=""/>
          <p:cNvPicPr/>
          <p:nvPr/>
        </p:nvPicPr>
        <p:blipFill>
          <a:blip r:embed="rId9"/>
          <a:stretch/>
        </p:blipFill>
        <p:spPr>
          <a:xfrm>
            <a:off x="5100480" y="4941720"/>
            <a:ext cx="1060560" cy="549360"/>
          </a:xfrm>
          <a:prstGeom prst="rect">
            <a:avLst/>
          </a:prstGeom>
          <a:ln w="0">
            <a:noFill/>
          </a:ln>
        </p:spPr>
      </p:pic>
      <p:cxnSp>
        <p:nvCxnSpPr>
          <p:cNvPr id="67" name="Straight Arrow Connector 45"/>
          <p:cNvCxnSpPr/>
          <p:nvPr/>
        </p:nvCxnSpPr>
        <p:spPr>
          <a:xfrm>
            <a:off x="4827240" y="4338720"/>
            <a:ext cx="548280" cy="475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68" name="Rectangle 46"/>
          <p:cNvSpPr/>
          <p:nvPr/>
        </p:nvSpPr>
        <p:spPr>
          <a:xfrm>
            <a:off x="1903320" y="3822840"/>
            <a:ext cx="1489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47"/>
          <p:cNvSpPr/>
          <p:nvPr/>
        </p:nvSpPr>
        <p:spPr>
          <a:xfrm>
            <a:off x="6297480" y="3760920"/>
            <a:ext cx="947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r>
              <a:rPr b="0" lang="en-US" sz="1200" spc="-1" strike="noStrike" u="sng" baseline="30000">
                <a:solidFill>
                  <a:srgbClr val="000000"/>
                </a:solidFill>
                <a:uFillTx/>
                <a:latin typeface="Arial"/>
              </a:rPr>
              <a:t>Dahome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48"/>
          <p:cNvSpPr/>
          <p:nvPr/>
        </p:nvSpPr>
        <p:spPr>
          <a:xfrm>
            <a:off x="6256800" y="498636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49"/>
          <p:cNvSpPr/>
          <p:nvPr/>
        </p:nvSpPr>
        <p:spPr>
          <a:xfrm>
            <a:off x="6558120" y="543888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ight Brace 9"/>
          <p:cNvSpPr/>
          <p:nvPr/>
        </p:nvSpPr>
        <p:spPr>
          <a:xfrm>
            <a:off x="7418520" y="4584600"/>
            <a:ext cx="529920" cy="1631880"/>
          </a:xfrm>
          <a:custGeom>
            <a:avLst/>
            <a:gdLst>
              <a:gd name="textAreaLeft" fmla="*/ 0 w 529920"/>
              <a:gd name="textAreaRight" fmla="*/ 191160 w 529920"/>
              <a:gd name="textAreaTop" fmla="*/ 13680 h 1631880"/>
              <a:gd name="textAreaBottom" fmla="*/ 1618200 h 1631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93"/>
                  <a:pt x="10800" y="585"/>
                </a:cubicBezTo>
                <a:lnTo>
                  <a:pt x="10800" y="10215"/>
                </a:lnTo>
                <a:cubicBezTo>
                  <a:pt x="10800" y="10508"/>
                  <a:pt x="16200" y="10800"/>
                  <a:pt x="21600" y="10800"/>
                </a:cubicBezTo>
                <a:cubicBezTo>
                  <a:pt x="16200" y="10800"/>
                  <a:pt x="10800" y="11093"/>
                  <a:pt x="10800" y="11385"/>
                </a:cubicBezTo>
                <a:lnTo>
                  <a:pt x="10800" y="21015"/>
                </a:lnTo>
                <a:cubicBezTo>
                  <a:pt x="10800" y="21308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50"/>
          <p:cNvSpPr/>
          <p:nvPr/>
        </p:nvSpPr>
        <p:spPr>
          <a:xfrm>
            <a:off x="8083440" y="5099040"/>
            <a:ext cx="2054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either SPR- or white male offspr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" name="Curved Connector 11"/>
          <p:cNvCxnSpPr>
            <a:stCxn id="65" idx="2"/>
            <a:endCxn id="75" idx="0"/>
          </p:cNvCxnSpPr>
          <p:nvPr/>
        </p:nvCxnSpPr>
        <p:spPr>
          <a:xfrm rot="5400000">
            <a:off x="3673800" y="5778000"/>
            <a:ext cx="1217880" cy="904680"/>
          </a:xfrm>
          <a:prstGeom prst="curvedConnector3">
            <a:avLst>
              <a:gd name="adj1" fmla="val 24955"/>
            </a:avLst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pic>
        <p:nvPicPr>
          <p:cNvPr id="76" name="Picture 53" descr=""/>
          <p:cNvPicPr/>
          <p:nvPr/>
        </p:nvPicPr>
        <p:blipFill>
          <a:blip r:embed="rId10"/>
          <a:stretch/>
        </p:blipFill>
        <p:spPr>
          <a:xfrm>
            <a:off x="5267160" y="7399440"/>
            <a:ext cx="1054440" cy="635040"/>
          </a:xfrm>
          <a:prstGeom prst="rect">
            <a:avLst/>
          </a:prstGeom>
          <a:ln w="0">
            <a:noFill/>
          </a:ln>
        </p:spPr>
      </p:pic>
      <p:sp>
        <p:nvSpPr>
          <p:cNvPr id="77" name="Rectangle 51"/>
          <p:cNvSpPr/>
          <p:nvPr/>
        </p:nvSpPr>
        <p:spPr>
          <a:xfrm>
            <a:off x="3087720" y="7229520"/>
            <a:ext cx="1450800" cy="1447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Picture 61" descr=""/>
          <p:cNvPicPr/>
          <p:nvPr/>
        </p:nvPicPr>
        <p:blipFill>
          <a:blip r:embed="rId11"/>
          <a:stretch/>
        </p:blipFill>
        <p:spPr>
          <a:xfrm>
            <a:off x="5265720" y="7985160"/>
            <a:ext cx="1055880" cy="554040"/>
          </a:xfrm>
          <a:prstGeom prst="rect">
            <a:avLst/>
          </a:prstGeom>
          <a:ln w="0">
            <a:noFill/>
          </a:ln>
        </p:spPr>
      </p:pic>
      <p:sp>
        <p:nvSpPr>
          <p:cNvPr id="79" name="Rectangle 62"/>
          <p:cNvSpPr/>
          <p:nvPr/>
        </p:nvSpPr>
        <p:spPr>
          <a:xfrm>
            <a:off x="5100480" y="7229520"/>
            <a:ext cx="1451160" cy="1447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0" name="Curved Connector 65"/>
          <p:cNvCxnSpPr>
            <a:stCxn id="65" idx="2"/>
            <a:endCxn id="81" idx="0"/>
          </p:cNvCxnSpPr>
          <p:nvPr/>
        </p:nvCxnSpPr>
        <p:spPr>
          <a:xfrm flipH="1" rot="16200000">
            <a:off x="4672080" y="5684040"/>
            <a:ext cx="1217880" cy="1092600"/>
          </a:xfrm>
          <a:prstGeom prst="curvedConnector3">
            <a:avLst>
              <a:gd name="adj1" fmla="val 24955"/>
            </a:avLst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82" name="Rectangle 69"/>
          <p:cNvSpPr/>
          <p:nvPr/>
        </p:nvSpPr>
        <p:spPr>
          <a:xfrm>
            <a:off x="1903320" y="5113440"/>
            <a:ext cx="1489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71"/>
          <p:cNvSpPr/>
          <p:nvPr/>
        </p:nvSpPr>
        <p:spPr>
          <a:xfrm>
            <a:off x="1716120" y="7491240"/>
            <a:ext cx="1487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72"/>
          <p:cNvSpPr/>
          <p:nvPr/>
        </p:nvSpPr>
        <p:spPr>
          <a:xfrm>
            <a:off x="1069920" y="757224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ctangle 73"/>
          <p:cNvSpPr/>
          <p:nvPr/>
        </p:nvSpPr>
        <p:spPr>
          <a:xfrm>
            <a:off x="1869840" y="802800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74"/>
          <p:cNvSpPr/>
          <p:nvPr/>
        </p:nvSpPr>
        <p:spPr>
          <a:xfrm>
            <a:off x="6627240" y="736920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75"/>
          <p:cNvSpPr/>
          <p:nvPr/>
        </p:nvSpPr>
        <p:spPr>
          <a:xfrm>
            <a:off x="6627240" y="790416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76"/>
          <p:cNvSpPr/>
          <p:nvPr/>
        </p:nvSpPr>
        <p:spPr>
          <a:xfrm>
            <a:off x="1068480" y="8104320"/>
            <a:ext cx="5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77"/>
          <p:cNvSpPr/>
          <p:nvPr/>
        </p:nvSpPr>
        <p:spPr>
          <a:xfrm>
            <a:off x="7302600" y="741996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78"/>
          <p:cNvSpPr/>
          <p:nvPr/>
        </p:nvSpPr>
        <p:spPr>
          <a:xfrm>
            <a:off x="7301160" y="7953480"/>
            <a:ext cx="5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81"/>
          <p:cNvSpPr/>
          <p:nvPr/>
        </p:nvSpPr>
        <p:spPr>
          <a:xfrm>
            <a:off x="2094120" y="2046240"/>
            <a:ext cx="91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enotyp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82"/>
          <p:cNvSpPr/>
          <p:nvPr/>
        </p:nvSpPr>
        <p:spPr>
          <a:xfrm>
            <a:off x="6356520" y="2046240"/>
            <a:ext cx="91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enotyp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83"/>
          <p:cNvSpPr/>
          <p:nvPr/>
        </p:nvSpPr>
        <p:spPr>
          <a:xfrm>
            <a:off x="3048120" y="6838920"/>
            <a:ext cx="156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PR- popul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86"/>
          <p:cNvSpPr/>
          <p:nvPr/>
        </p:nvSpPr>
        <p:spPr>
          <a:xfrm>
            <a:off x="4941000" y="6838920"/>
            <a:ext cx="1771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 popul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ight Brace 48"/>
          <p:cNvSpPr/>
          <p:nvPr/>
        </p:nvSpPr>
        <p:spPr>
          <a:xfrm>
            <a:off x="7392960" y="3687840"/>
            <a:ext cx="530280" cy="7286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728640"/>
              <a:gd name="textAreaBottom" fmla="*/ 714960 h 728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55"/>
                  <a:pt x="10800" y="1310"/>
                </a:cubicBezTo>
                <a:lnTo>
                  <a:pt x="10800" y="9490"/>
                </a:lnTo>
                <a:cubicBezTo>
                  <a:pt x="10800" y="10145"/>
                  <a:pt x="16200" y="10800"/>
                  <a:pt x="21600" y="10800"/>
                </a:cubicBezTo>
                <a:cubicBezTo>
                  <a:pt x="16200" y="10800"/>
                  <a:pt x="10800" y="11455"/>
                  <a:pt x="10800" y="12110"/>
                </a:cubicBezTo>
                <a:lnTo>
                  <a:pt x="10800" y="20290"/>
                </a:lnTo>
                <a:cubicBezTo>
                  <a:pt x="10800" y="2094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39"/>
          <p:cNvSpPr/>
          <p:nvPr/>
        </p:nvSpPr>
        <p:spPr>
          <a:xfrm>
            <a:off x="600120" y="2714760"/>
            <a:ext cx="942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hit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ahome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39"/>
          <p:cNvSpPr/>
          <p:nvPr/>
        </p:nvSpPr>
        <p:spPr>
          <a:xfrm>
            <a:off x="7542360" y="2714760"/>
            <a:ext cx="1860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PR-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eficiency (red eye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39"/>
          <p:cNvSpPr/>
          <p:nvPr/>
        </p:nvSpPr>
        <p:spPr>
          <a:xfrm>
            <a:off x="596520" y="3790800"/>
            <a:ext cx="14518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terozygot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 offspr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orange eye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39"/>
          <p:cNvSpPr/>
          <p:nvPr/>
        </p:nvSpPr>
        <p:spPr>
          <a:xfrm>
            <a:off x="596160" y="5022720"/>
            <a:ext cx="15019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terozygot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 offspring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orange eye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ight Brace 57"/>
          <p:cNvSpPr/>
          <p:nvPr/>
        </p:nvSpPr>
        <p:spPr>
          <a:xfrm>
            <a:off x="7886880" y="7045200"/>
            <a:ext cx="531720" cy="1632240"/>
          </a:xfrm>
          <a:custGeom>
            <a:avLst/>
            <a:gdLst>
              <a:gd name="textAreaLeft" fmla="*/ 0 w 531720"/>
              <a:gd name="textAreaRight" fmla="*/ 191880 w 531720"/>
              <a:gd name="textAreaTop" fmla="*/ 13680 h 1632240"/>
              <a:gd name="textAreaBottom" fmla="*/ 1618560 h 1632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94"/>
                  <a:pt x="10800" y="587"/>
                </a:cubicBezTo>
                <a:lnTo>
                  <a:pt x="10800" y="10213"/>
                </a:lnTo>
                <a:cubicBezTo>
                  <a:pt x="10800" y="10507"/>
                  <a:pt x="16200" y="10800"/>
                  <a:pt x="21600" y="10800"/>
                </a:cubicBezTo>
                <a:cubicBezTo>
                  <a:pt x="16200" y="10800"/>
                  <a:pt x="10800" y="11094"/>
                  <a:pt x="10800" y="11387"/>
                </a:cubicBezTo>
                <a:lnTo>
                  <a:pt x="10800" y="21013"/>
                </a:lnTo>
                <a:cubicBezTo>
                  <a:pt x="10800" y="21307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50"/>
          <p:cNvSpPr/>
          <p:nvPr/>
        </p:nvSpPr>
        <p:spPr>
          <a:xfrm>
            <a:off x="8464680" y="7542360"/>
            <a:ext cx="20541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unselected SPR- (red-eyed) and control (white-eyed) popula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0" name="Straight Arrow Connector 53"/>
          <p:cNvCxnSpPr/>
          <p:nvPr/>
        </p:nvCxnSpPr>
        <p:spPr>
          <a:xfrm flipH="1">
            <a:off x="3087000" y="8930880"/>
            <a:ext cx="54828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01" name="Straight Arrow Connector 54"/>
          <p:cNvCxnSpPr/>
          <p:nvPr/>
        </p:nvCxnSpPr>
        <p:spPr>
          <a:xfrm>
            <a:off x="3916080" y="8922960"/>
            <a:ext cx="54828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02" name="Straight Arrow Connector 55"/>
          <p:cNvCxnSpPr/>
          <p:nvPr/>
        </p:nvCxnSpPr>
        <p:spPr>
          <a:xfrm flipH="1">
            <a:off x="3578040" y="8938800"/>
            <a:ext cx="173520" cy="467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03" name="Straight Arrow Connector 58"/>
          <p:cNvCxnSpPr/>
          <p:nvPr/>
        </p:nvCxnSpPr>
        <p:spPr>
          <a:xfrm>
            <a:off x="3843360" y="8946720"/>
            <a:ext cx="155880" cy="4518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04" name="TextBox 83"/>
          <p:cNvSpPr/>
          <p:nvPr/>
        </p:nvSpPr>
        <p:spPr>
          <a:xfrm>
            <a:off x="2806560" y="9472680"/>
            <a:ext cx="18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1     S2     S3    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5" name="Straight Arrow Connector 63"/>
          <p:cNvCxnSpPr/>
          <p:nvPr/>
        </p:nvCxnSpPr>
        <p:spPr>
          <a:xfrm flipH="1">
            <a:off x="5208120" y="8930880"/>
            <a:ext cx="54864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06" name="Straight Arrow Connector 64"/>
          <p:cNvCxnSpPr/>
          <p:nvPr/>
        </p:nvCxnSpPr>
        <p:spPr>
          <a:xfrm>
            <a:off x="6037200" y="8922960"/>
            <a:ext cx="54864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07" name="Straight Arrow Connector 66"/>
          <p:cNvCxnSpPr/>
          <p:nvPr/>
        </p:nvCxnSpPr>
        <p:spPr>
          <a:xfrm flipH="1">
            <a:off x="5698440" y="8938800"/>
            <a:ext cx="173880" cy="467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08" name="Straight Arrow Connector 67"/>
          <p:cNvCxnSpPr/>
          <p:nvPr/>
        </p:nvCxnSpPr>
        <p:spPr>
          <a:xfrm>
            <a:off x="5964120" y="8946720"/>
            <a:ext cx="155880" cy="4518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09" name="TextBox 83"/>
          <p:cNvSpPr/>
          <p:nvPr/>
        </p:nvSpPr>
        <p:spPr>
          <a:xfrm>
            <a:off x="4928400" y="9472680"/>
            <a:ext cx="1893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1     C2     C3     C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tangle 19"/>
          <p:cNvSpPr/>
          <p:nvPr/>
        </p:nvSpPr>
        <p:spPr>
          <a:xfrm>
            <a:off x="7954920" y="9242280"/>
            <a:ext cx="2311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replicate experimental evolution lin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ight Brace 70"/>
          <p:cNvSpPr/>
          <p:nvPr/>
        </p:nvSpPr>
        <p:spPr>
          <a:xfrm>
            <a:off x="7392960" y="9244080"/>
            <a:ext cx="530280" cy="7286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728640"/>
              <a:gd name="textAreaBottom" fmla="*/ 714960 h 728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55"/>
                  <a:pt x="10800" y="1310"/>
                </a:cubicBezTo>
                <a:lnTo>
                  <a:pt x="10800" y="9490"/>
                </a:lnTo>
                <a:cubicBezTo>
                  <a:pt x="10800" y="10145"/>
                  <a:pt x="16200" y="10800"/>
                  <a:pt x="21600" y="10800"/>
                </a:cubicBezTo>
                <a:cubicBezTo>
                  <a:pt x="16200" y="10800"/>
                  <a:pt x="10800" y="11455"/>
                  <a:pt x="10800" y="12110"/>
                </a:cubicBezTo>
                <a:lnTo>
                  <a:pt x="10800" y="20290"/>
                </a:lnTo>
                <a:cubicBezTo>
                  <a:pt x="10800" y="2094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83"/>
          <p:cNvSpPr/>
          <p:nvPr/>
        </p:nvSpPr>
        <p:spPr>
          <a:xfrm>
            <a:off x="1944720" y="1290600"/>
            <a:ext cx="626148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enerating starting (unselected) populations for experimental evolu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5"/>
          <p:cNvSpPr/>
          <p:nvPr/>
        </p:nvSpPr>
        <p:spPr>
          <a:xfrm>
            <a:off x="499680" y="399960"/>
            <a:ext cx="115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Rectangle 6"/>
          <p:cNvSpPr/>
          <p:nvPr/>
        </p:nvSpPr>
        <p:spPr>
          <a:xfrm>
            <a:off x="4032360" y="2494080"/>
            <a:ext cx="1450800" cy="1447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72"/>
          <p:cNvSpPr/>
          <p:nvPr/>
        </p:nvSpPr>
        <p:spPr>
          <a:xfrm>
            <a:off x="6759720" y="278460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76"/>
          <p:cNvSpPr/>
          <p:nvPr/>
        </p:nvSpPr>
        <p:spPr>
          <a:xfrm>
            <a:off x="6758280" y="3316320"/>
            <a:ext cx="5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83"/>
          <p:cNvSpPr/>
          <p:nvPr/>
        </p:nvSpPr>
        <p:spPr>
          <a:xfrm>
            <a:off x="1329840" y="1646280"/>
            <a:ext cx="739080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reating extra controls for sperm competition experiments: “SPR+ evolved controls”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3"/>
          <p:cNvSpPr/>
          <p:nvPr/>
        </p:nvSpPr>
        <p:spPr>
          <a:xfrm>
            <a:off x="3744720" y="2122560"/>
            <a:ext cx="1893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1     C2     C3     C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Rectangle 19"/>
          <p:cNvSpPr/>
          <p:nvPr/>
        </p:nvSpPr>
        <p:spPr>
          <a:xfrm>
            <a:off x="7993080" y="4506840"/>
            <a:ext cx="2311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SPR- (unselected, red-eyed) 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ectangle 38"/>
          <p:cNvSpPr/>
          <p:nvPr/>
        </p:nvSpPr>
        <p:spPr>
          <a:xfrm>
            <a:off x="4591800" y="46893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Right Brace 44"/>
          <p:cNvSpPr/>
          <p:nvPr/>
        </p:nvSpPr>
        <p:spPr>
          <a:xfrm>
            <a:off x="7431120" y="4508640"/>
            <a:ext cx="530280" cy="7286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728640"/>
              <a:gd name="textAreaBottom" fmla="*/ 714960 h 728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55"/>
                  <a:pt x="10800" y="1310"/>
                </a:cubicBezTo>
                <a:lnTo>
                  <a:pt x="10800" y="9490"/>
                </a:lnTo>
                <a:cubicBezTo>
                  <a:pt x="10800" y="10145"/>
                  <a:pt x="16200" y="10800"/>
                  <a:pt x="21600" y="10800"/>
                </a:cubicBezTo>
                <a:cubicBezTo>
                  <a:pt x="16200" y="10800"/>
                  <a:pt x="10800" y="11455"/>
                  <a:pt x="10800" y="12110"/>
                </a:cubicBezTo>
                <a:lnTo>
                  <a:pt x="10800" y="20290"/>
                </a:lnTo>
                <a:cubicBezTo>
                  <a:pt x="10800" y="2094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" name="Picture 6" descr=""/>
          <p:cNvPicPr/>
          <p:nvPr/>
        </p:nvPicPr>
        <p:blipFill>
          <a:blip r:embed="rId1"/>
          <a:stretch/>
        </p:blipFill>
        <p:spPr>
          <a:xfrm>
            <a:off x="3273480" y="5845320"/>
            <a:ext cx="1063440" cy="649080"/>
          </a:xfrm>
          <a:prstGeom prst="rect">
            <a:avLst/>
          </a:prstGeom>
          <a:ln w="0">
            <a:noFill/>
          </a:ln>
        </p:spPr>
      </p:pic>
      <p:cxnSp>
        <p:nvCxnSpPr>
          <p:cNvPr id="123" name="Straight Arrow Connector 46"/>
          <p:cNvCxnSpPr/>
          <p:nvPr/>
        </p:nvCxnSpPr>
        <p:spPr>
          <a:xfrm flipH="1">
            <a:off x="4046040" y="5253120"/>
            <a:ext cx="548640" cy="4737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24" name="Rectangle 46"/>
          <p:cNvSpPr/>
          <p:nvPr/>
        </p:nvSpPr>
        <p:spPr>
          <a:xfrm>
            <a:off x="1946160" y="5940360"/>
            <a:ext cx="1489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39"/>
          <p:cNvSpPr/>
          <p:nvPr/>
        </p:nvSpPr>
        <p:spPr>
          <a:xfrm>
            <a:off x="642960" y="5908680"/>
            <a:ext cx="15494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terozygot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 offspr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1, C2, C3 or C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Rectangle 35"/>
          <p:cNvSpPr/>
          <p:nvPr/>
        </p:nvSpPr>
        <p:spPr>
          <a:xfrm>
            <a:off x="6599520" y="5886360"/>
            <a:ext cx="570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Rectangle 36"/>
          <p:cNvSpPr/>
          <p:nvPr/>
        </p:nvSpPr>
        <p:spPr>
          <a:xfrm>
            <a:off x="4595040" y="59292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Rectangle 19"/>
          <p:cNvSpPr/>
          <p:nvPr/>
        </p:nvSpPr>
        <p:spPr>
          <a:xfrm>
            <a:off x="7993080" y="5748480"/>
            <a:ext cx="23115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males from same evolved control line </a:t>
            </a:r>
            <a:br>
              <a:rPr sz="1400"/>
            </a:b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(C1, C2, C3 or C4)</a:t>
            </a:r>
            <a:br>
              <a:rPr sz="1400"/>
            </a:b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repeated x 6 genera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Right Brace 54"/>
          <p:cNvSpPr/>
          <p:nvPr/>
        </p:nvSpPr>
        <p:spPr>
          <a:xfrm>
            <a:off x="7431120" y="5749920"/>
            <a:ext cx="530280" cy="7286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728640"/>
              <a:gd name="textAreaBottom" fmla="*/ 714960 h 728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55"/>
                  <a:pt x="10800" y="1310"/>
                </a:cubicBezTo>
                <a:lnTo>
                  <a:pt x="10800" y="9490"/>
                </a:lnTo>
                <a:cubicBezTo>
                  <a:pt x="10800" y="10145"/>
                  <a:pt x="16200" y="10800"/>
                  <a:pt x="21600" y="10800"/>
                </a:cubicBezTo>
                <a:cubicBezTo>
                  <a:pt x="16200" y="10800"/>
                  <a:pt x="10800" y="11455"/>
                  <a:pt x="10800" y="12110"/>
                </a:cubicBezTo>
                <a:lnTo>
                  <a:pt x="10800" y="20290"/>
                </a:lnTo>
                <a:cubicBezTo>
                  <a:pt x="10800" y="2094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ectangle 46"/>
          <p:cNvSpPr/>
          <p:nvPr/>
        </p:nvSpPr>
        <p:spPr>
          <a:xfrm>
            <a:off x="1994040" y="4630680"/>
            <a:ext cx="148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39"/>
          <p:cNvSpPr/>
          <p:nvPr/>
        </p:nvSpPr>
        <p:spPr>
          <a:xfrm>
            <a:off x="689400" y="4599000"/>
            <a:ext cx="11134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1, C2, C3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 C4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2" name="Picture 6" descr=""/>
          <p:cNvPicPr/>
          <p:nvPr/>
        </p:nvPicPr>
        <p:blipFill>
          <a:blip r:embed="rId2"/>
          <a:stretch/>
        </p:blipFill>
        <p:spPr>
          <a:xfrm>
            <a:off x="3270240" y="7080120"/>
            <a:ext cx="1063800" cy="649440"/>
          </a:xfrm>
          <a:prstGeom prst="rect">
            <a:avLst/>
          </a:prstGeom>
          <a:ln w="0">
            <a:noFill/>
          </a:ln>
        </p:spPr>
      </p:pic>
      <p:cxnSp>
        <p:nvCxnSpPr>
          <p:cNvPr id="133" name="Straight Arrow Connector 59"/>
          <p:cNvCxnSpPr/>
          <p:nvPr/>
        </p:nvCxnSpPr>
        <p:spPr>
          <a:xfrm flipH="1">
            <a:off x="4041360" y="6369120"/>
            <a:ext cx="548640" cy="475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34" name="Rectangle 43"/>
          <p:cNvSpPr/>
          <p:nvPr/>
        </p:nvSpPr>
        <p:spPr>
          <a:xfrm>
            <a:off x="4629960" y="72756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35" name="Straight Arrow Connector 62"/>
          <p:cNvCxnSpPr/>
          <p:nvPr/>
        </p:nvCxnSpPr>
        <p:spPr>
          <a:xfrm>
            <a:off x="4870080" y="6361200"/>
            <a:ext cx="548280" cy="475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36" name="TextBox 49"/>
          <p:cNvSpPr/>
          <p:nvPr/>
        </p:nvSpPr>
        <p:spPr>
          <a:xfrm>
            <a:off x="6440040" y="7194600"/>
            <a:ext cx="1157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ight Brace 65"/>
          <p:cNvSpPr/>
          <p:nvPr/>
        </p:nvSpPr>
        <p:spPr>
          <a:xfrm>
            <a:off x="7461360" y="7121520"/>
            <a:ext cx="530280" cy="6080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608040"/>
              <a:gd name="textAreaBottom" fmla="*/ 594360 h 6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85"/>
                  <a:pt x="10800" y="1570"/>
                </a:cubicBezTo>
                <a:lnTo>
                  <a:pt x="10800" y="9230"/>
                </a:lnTo>
                <a:cubicBezTo>
                  <a:pt x="10800" y="10015"/>
                  <a:pt x="16200" y="10800"/>
                  <a:pt x="21600" y="10800"/>
                </a:cubicBezTo>
                <a:cubicBezTo>
                  <a:pt x="16200" y="10800"/>
                  <a:pt x="10800" y="11585"/>
                  <a:pt x="10800" y="12370"/>
                </a:cubicBezTo>
                <a:lnTo>
                  <a:pt x="10800" y="20030"/>
                </a:lnTo>
                <a:cubicBezTo>
                  <a:pt x="10800" y="2081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Rectangle 50"/>
          <p:cNvSpPr/>
          <p:nvPr/>
        </p:nvSpPr>
        <p:spPr>
          <a:xfrm>
            <a:off x="8126280" y="7121520"/>
            <a:ext cx="20545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SPR- male offspring from same line and cros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Rectangle 69"/>
          <p:cNvSpPr/>
          <p:nvPr/>
        </p:nvSpPr>
        <p:spPr>
          <a:xfrm>
            <a:off x="1946160" y="7254720"/>
            <a:ext cx="1489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39"/>
          <p:cNvSpPr/>
          <p:nvPr/>
        </p:nvSpPr>
        <p:spPr>
          <a:xfrm>
            <a:off x="642960" y="7045200"/>
            <a:ext cx="15494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terozygot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 offspr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1, C2, C3 or C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1" name="Straight Arrow Connector 70"/>
          <p:cNvCxnSpPr/>
          <p:nvPr/>
        </p:nvCxnSpPr>
        <p:spPr>
          <a:xfrm flipH="1">
            <a:off x="4053960" y="7644960"/>
            <a:ext cx="54864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42" name="Straight Arrow Connector 71"/>
          <p:cNvCxnSpPr/>
          <p:nvPr/>
        </p:nvCxnSpPr>
        <p:spPr>
          <a:xfrm>
            <a:off x="4883040" y="7637040"/>
            <a:ext cx="54864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43" name="Right Brace 76"/>
          <p:cNvSpPr/>
          <p:nvPr/>
        </p:nvSpPr>
        <p:spPr>
          <a:xfrm>
            <a:off x="7451640" y="8354880"/>
            <a:ext cx="530280" cy="6080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608040"/>
              <a:gd name="textAreaBottom" fmla="*/ 594360 h 6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85"/>
                  <a:pt x="10800" y="1570"/>
                </a:cubicBezTo>
                <a:lnTo>
                  <a:pt x="10800" y="9230"/>
                </a:lnTo>
                <a:cubicBezTo>
                  <a:pt x="10800" y="10015"/>
                  <a:pt x="16200" y="10800"/>
                  <a:pt x="21600" y="10800"/>
                </a:cubicBezTo>
                <a:cubicBezTo>
                  <a:pt x="16200" y="10800"/>
                  <a:pt x="10800" y="11585"/>
                  <a:pt x="10800" y="12370"/>
                </a:cubicBezTo>
                <a:lnTo>
                  <a:pt x="10800" y="20030"/>
                </a:lnTo>
                <a:cubicBezTo>
                  <a:pt x="10800" y="2081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Rectangle 50"/>
          <p:cNvSpPr/>
          <p:nvPr/>
        </p:nvSpPr>
        <p:spPr>
          <a:xfrm>
            <a:off x="8102520" y="8273880"/>
            <a:ext cx="20541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PR- (red-eyed) flies in SPR+ (control) evolved genetic backgroun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5" name="Straight Arrow Connector 79"/>
          <p:cNvCxnSpPr/>
          <p:nvPr/>
        </p:nvCxnSpPr>
        <p:spPr>
          <a:xfrm>
            <a:off x="4092120" y="8996040"/>
            <a:ext cx="3960" cy="4309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146" name="Straight Arrow Connector 80"/>
          <p:cNvCxnSpPr/>
          <p:nvPr/>
        </p:nvCxnSpPr>
        <p:spPr>
          <a:xfrm>
            <a:off x="5452560" y="8969040"/>
            <a:ext cx="2520" cy="4309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47" name="TextBox 83"/>
          <p:cNvSpPr/>
          <p:nvPr/>
        </p:nvSpPr>
        <p:spPr>
          <a:xfrm>
            <a:off x="3867840" y="10983960"/>
            <a:ext cx="1893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1     C2     C3     C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8" name="Straight Arrow Connector 91"/>
          <p:cNvCxnSpPr/>
          <p:nvPr/>
        </p:nvCxnSpPr>
        <p:spPr>
          <a:xfrm flipH="1">
            <a:off x="4166640" y="4041360"/>
            <a:ext cx="54828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49" name="Right Brace 93"/>
          <p:cNvSpPr/>
          <p:nvPr/>
        </p:nvSpPr>
        <p:spPr>
          <a:xfrm>
            <a:off x="7383600" y="2387520"/>
            <a:ext cx="531720" cy="1631880"/>
          </a:xfrm>
          <a:custGeom>
            <a:avLst/>
            <a:gdLst>
              <a:gd name="textAreaLeft" fmla="*/ 0 w 531720"/>
              <a:gd name="textAreaRight" fmla="*/ 191880 w 531720"/>
              <a:gd name="textAreaTop" fmla="*/ 13680 h 1631880"/>
              <a:gd name="textAreaBottom" fmla="*/ 1618200 h 1631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94"/>
                  <a:pt x="10800" y="587"/>
                </a:cubicBezTo>
                <a:lnTo>
                  <a:pt x="10800" y="10213"/>
                </a:lnTo>
                <a:cubicBezTo>
                  <a:pt x="10800" y="10507"/>
                  <a:pt x="16200" y="10800"/>
                  <a:pt x="21600" y="10800"/>
                </a:cubicBezTo>
                <a:cubicBezTo>
                  <a:pt x="16200" y="10800"/>
                  <a:pt x="10800" y="11094"/>
                  <a:pt x="10800" y="11387"/>
                </a:cubicBezTo>
                <a:lnTo>
                  <a:pt x="10800" y="21013"/>
                </a:lnTo>
                <a:cubicBezTo>
                  <a:pt x="10800" y="21307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ectangle 50"/>
          <p:cNvSpPr/>
          <p:nvPr/>
        </p:nvSpPr>
        <p:spPr>
          <a:xfrm>
            <a:off x="7961400" y="2884320"/>
            <a:ext cx="21952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PR+ evolved (control, white-eyed) popula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1" name="Picture 53" descr=""/>
          <p:cNvPicPr/>
          <p:nvPr/>
        </p:nvPicPr>
        <p:blipFill>
          <a:blip r:embed="rId3"/>
          <a:stretch/>
        </p:blipFill>
        <p:spPr>
          <a:xfrm>
            <a:off x="4311720" y="2697120"/>
            <a:ext cx="1054080" cy="63504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61" descr=""/>
          <p:cNvPicPr/>
          <p:nvPr/>
        </p:nvPicPr>
        <p:blipFill>
          <a:blip r:embed="rId4"/>
          <a:stretch/>
        </p:blipFill>
        <p:spPr>
          <a:xfrm>
            <a:off x="4309920" y="3282840"/>
            <a:ext cx="1055880" cy="554040"/>
          </a:xfrm>
          <a:prstGeom prst="rect">
            <a:avLst/>
          </a:prstGeom>
          <a:ln w="0">
            <a:noFill/>
          </a:ln>
        </p:spPr>
      </p:pic>
      <p:sp>
        <p:nvSpPr>
          <p:cNvPr id="153" name="TextBox 74"/>
          <p:cNvSpPr/>
          <p:nvPr/>
        </p:nvSpPr>
        <p:spPr>
          <a:xfrm>
            <a:off x="5671440" y="266688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75"/>
          <p:cNvSpPr/>
          <p:nvPr/>
        </p:nvSpPr>
        <p:spPr>
          <a:xfrm>
            <a:off x="5671440" y="320184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5" name="Picture 53" descr=""/>
          <p:cNvPicPr/>
          <p:nvPr/>
        </p:nvPicPr>
        <p:blipFill>
          <a:blip r:embed="rId5"/>
          <a:stretch/>
        </p:blipFill>
        <p:spPr>
          <a:xfrm>
            <a:off x="3281400" y="4602240"/>
            <a:ext cx="1054080" cy="63504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4" descr=""/>
          <p:cNvPicPr/>
          <p:nvPr/>
        </p:nvPicPr>
        <p:blipFill>
          <a:blip r:embed="rId6"/>
          <a:stretch/>
        </p:blipFill>
        <p:spPr>
          <a:xfrm>
            <a:off x="5275440" y="4610160"/>
            <a:ext cx="1060200" cy="550800"/>
          </a:xfrm>
          <a:prstGeom prst="rect">
            <a:avLst/>
          </a:prstGeom>
          <a:ln w="0">
            <a:noFill/>
          </a:ln>
        </p:spPr>
      </p:pic>
      <p:sp>
        <p:nvSpPr>
          <p:cNvPr id="157" name="Rectangle 35"/>
          <p:cNvSpPr/>
          <p:nvPr/>
        </p:nvSpPr>
        <p:spPr>
          <a:xfrm>
            <a:off x="6418800" y="465444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8" name="Picture 61" descr=""/>
          <p:cNvPicPr/>
          <p:nvPr/>
        </p:nvPicPr>
        <p:blipFill>
          <a:blip r:embed="rId7"/>
          <a:stretch/>
        </p:blipFill>
        <p:spPr>
          <a:xfrm>
            <a:off x="5276880" y="5834160"/>
            <a:ext cx="1055520" cy="55404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4" descr=""/>
          <p:cNvPicPr/>
          <p:nvPr/>
        </p:nvPicPr>
        <p:blipFill>
          <a:blip r:embed="rId8"/>
          <a:stretch/>
        </p:blipFill>
        <p:spPr>
          <a:xfrm>
            <a:off x="5362560" y="7086600"/>
            <a:ext cx="1060560" cy="550800"/>
          </a:xfrm>
          <a:prstGeom prst="rect">
            <a:avLst/>
          </a:prstGeom>
          <a:ln w="0">
            <a:noFill/>
          </a:ln>
        </p:spPr>
      </p:pic>
      <p:pic>
        <p:nvPicPr>
          <p:cNvPr id="160" name="Picture 3" descr=""/>
          <p:cNvPicPr/>
          <p:nvPr/>
        </p:nvPicPr>
        <p:blipFill>
          <a:blip r:embed="rId9"/>
          <a:stretch/>
        </p:blipFill>
        <p:spPr>
          <a:xfrm>
            <a:off x="3282840" y="8291520"/>
            <a:ext cx="1060560" cy="652320"/>
          </a:xfrm>
          <a:prstGeom prst="rect">
            <a:avLst/>
          </a:prstGeom>
          <a:ln w="0">
            <a:noFill/>
          </a:ln>
        </p:spPr>
      </p:pic>
      <p:pic>
        <p:nvPicPr>
          <p:cNvPr id="161" name="Picture 4" descr=""/>
          <p:cNvPicPr/>
          <p:nvPr/>
        </p:nvPicPr>
        <p:blipFill>
          <a:blip r:embed="rId10"/>
          <a:stretch/>
        </p:blipFill>
        <p:spPr>
          <a:xfrm>
            <a:off x="5397480" y="8342280"/>
            <a:ext cx="1060560" cy="550800"/>
          </a:xfrm>
          <a:prstGeom prst="rect">
            <a:avLst/>
          </a:prstGeom>
          <a:ln w="0">
            <a:noFill/>
          </a:ln>
        </p:spPr>
      </p:pic>
      <p:sp>
        <p:nvSpPr>
          <p:cNvPr id="162" name="Rectangle 71"/>
          <p:cNvSpPr/>
          <p:nvPr/>
        </p:nvSpPr>
        <p:spPr>
          <a:xfrm>
            <a:off x="1947960" y="8273880"/>
            <a:ext cx="1487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Rectangle 73"/>
          <p:cNvSpPr/>
          <p:nvPr/>
        </p:nvSpPr>
        <p:spPr>
          <a:xfrm>
            <a:off x="6438600" y="834552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4" name="Picture 4" descr=""/>
          <p:cNvPicPr/>
          <p:nvPr/>
        </p:nvPicPr>
        <p:blipFill>
          <a:blip r:embed="rId11"/>
          <a:stretch/>
        </p:blipFill>
        <p:spPr>
          <a:xfrm>
            <a:off x="4148280" y="10250640"/>
            <a:ext cx="1060200" cy="55080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3" descr=""/>
          <p:cNvPicPr/>
          <p:nvPr/>
        </p:nvPicPr>
        <p:blipFill>
          <a:blip r:embed="rId12"/>
          <a:stretch/>
        </p:blipFill>
        <p:spPr>
          <a:xfrm>
            <a:off x="4265640" y="9656640"/>
            <a:ext cx="1060560" cy="652680"/>
          </a:xfrm>
          <a:prstGeom prst="rect">
            <a:avLst/>
          </a:prstGeom>
          <a:ln w="0">
            <a:noFill/>
          </a:ln>
        </p:spPr>
      </p:pic>
      <p:sp>
        <p:nvSpPr>
          <p:cNvPr id="166" name="Rectangle 107"/>
          <p:cNvSpPr/>
          <p:nvPr/>
        </p:nvSpPr>
        <p:spPr>
          <a:xfrm>
            <a:off x="4052880" y="9487080"/>
            <a:ext cx="1451160" cy="1447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Rectangle 71"/>
          <p:cNvSpPr/>
          <p:nvPr/>
        </p:nvSpPr>
        <p:spPr>
          <a:xfrm>
            <a:off x="5456160" y="9759960"/>
            <a:ext cx="1487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72"/>
          <p:cNvSpPr/>
          <p:nvPr/>
        </p:nvSpPr>
        <p:spPr>
          <a:xfrm>
            <a:off x="6780240" y="977724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Rectangle 73"/>
          <p:cNvSpPr/>
          <p:nvPr/>
        </p:nvSpPr>
        <p:spPr>
          <a:xfrm>
            <a:off x="5609880" y="1029636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76"/>
          <p:cNvSpPr/>
          <p:nvPr/>
        </p:nvSpPr>
        <p:spPr>
          <a:xfrm>
            <a:off x="6778800" y="10309320"/>
            <a:ext cx="5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Right Brace 112"/>
          <p:cNvSpPr/>
          <p:nvPr/>
        </p:nvSpPr>
        <p:spPr>
          <a:xfrm>
            <a:off x="7404120" y="9379080"/>
            <a:ext cx="531720" cy="1631880"/>
          </a:xfrm>
          <a:custGeom>
            <a:avLst/>
            <a:gdLst>
              <a:gd name="textAreaLeft" fmla="*/ 0 w 531720"/>
              <a:gd name="textAreaRight" fmla="*/ 191880 w 531720"/>
              <a:gd name="textAreaTop" fmla="*/ 13680 h 1631880"/>
              <a:gd name="textAreaBottom" fmla="*/ 1618200 h 1631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94"/>
                  <a:pt x="10800" y="587"/>
                </a:cubicBezTo>
                <a:lnTo>
                  <a:pt x="10800" y="10213"/>
                </a:lnTo>
                <a:cubicBezTo>
                  <a:pt x="10800" y="10507"/>
                  <a:pt x="16200" y="10800"/>
                  <a:pt x="21600" y="10800"/>
                </a:cubicBezTo>
                <a:cubicBezTo>
                  <a:pt x="16200" y="10800"/>
                  <a:pt x="10800" y="11094"/>
                  <a:pt x="10800" y="11387"/>
                </a:cubicBezTo>
                <a:lnTo>
                  <a:pt x="10800" y="21013"/>
                </a:lnTo>
                <a:cubicBezTo>
                  <a:pt x="10800" y="21307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Rectangle 50"/>
          <p:cNvSpPr/>
          <p:nvPr/>
        </p:nvSpPr>
        <p:spPr>
          <a:xfrm>
            <a:off x="7981920" y="9875880"/>
            <a:ext cx="2054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PR+ evolved control” popula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114"/>
          <p:cNvSpPr/>
          <p:nvPr/>
        </p:nvSpPr>
        <p:spPr>
          <a:xfrm>
            <a:off x="499680" y="399960"/>
            <a:ext cx="115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" name="Picture 4" descr=""/>
          <p:cNvPicPr/>
          <p:nvPr/>
        </p:nvPicPr>
        <p:blipFill>
          <a:blip r:embed="rId1"/>
          <a:stretch/>
        </p:blipFill>
        <p:spPr>
          <a:xfrm>
            <a:off x="4317840" y="3079800"/>
            <a:ext cx="1060560" cy="55080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3" descr=""/>
          <p:cNvPicPr/>
          <p:nvPr/>
        </p:nvPicPr>
        <p:blipFill>
          <a:blip r:embed="rId2"/>
          <a:stretch/>
        </p:blipFill>
        <p:spPr>
          <a:xfrm>
            <a:off x="4435560" y="2486160"/>
            <a:ext cx="1060200" cy="652320"/>
          </a:xfrm>
          <a:prstGeom prst="rect">
            <a:avLst/>
          </a:prstGeom>
          <a:ln w="0">
            <a:noFill/>
          </a:ln>
        </p:spPr>
      </p:pic>
      <p:sp>
        <p:nvSpPr>
          <p:cNvPr id="176" name="Rectangle 6"/>
          <p:cNvSpPr/>
          <p:nvPr/>
        </p:nvSpPr>
        <p:spPr>
          <a:xfrm>
            <a:off x="4222800" y="2316240"/>
            <a:ext cx="1450800" cy="1447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Rectangle 71"/>
          <p:cNvSpPr/>
          <p:nvPr/>
        </p:nvSpPr>
        <p:spPr>
          <a:xfrm>
            <a:off x="5626080" y="2590920"/>
            <a:ext cx="1487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72"/>
          <p:cNvSpPr/>
          <p:nvPr/>
        </p:nvSpPr>
        <p:spPr>
          <a:xfrm>
            <a:off x="6950160" y="260676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Rectangle 73"/>
          <p:cNvSpPr/>
          <p:nvPr/>
        </p:nvSpPr>
        <p:spPr>
          <a:xfrm>
            <a:off x="5779800" y="312732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76"/>
          <p:cNvSpPr/>
          <p:nvPr/>
        </p:nvSpPr>
        <p:spPr>
          <a:xfrm>
            <a:off x="6948720" y="3138480"/>
            <a:ext cx="5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83"/>
          <p:cNvSpPr/>
          <p:nvPr/>
        </p:nvSpPr>
        <p:spPr>
          <a:xfrm>
            <a:off x="1542240" y="1468440"/>
            <a:ext cx="73465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reating extra controls for sperm competition experiments: “SPR- evolved controls”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Box 83"/>
          <p:cNvSpPr/>
          <p:nvPr/>
        </p:nvSpPr>
        <p:spPr>
          <a:xfrm>
            <a:off x="3959280" y="1944720"/>
            <a:ext cx="18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1     S2     S3    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3" name="Picture 3" descr=""/>
          <p:cNvPicPr/>
          <p:nvPr/>
        </p:nvPicPr>
        <p:blipFill>
          <a:blip r:embed="rId3"/>
          <a:stretch/>
        </p:blipFill>
        <p:spPr>
          <a:xfrm>
            <a:off x="3541680" y="4422600"/>
            <a:ext cx="1060560" cy="652680"/>
          </a:xfrm>
          <a:prstGeom prst="rect">
            <a:avLst/>
          </a:prstGeom>
          <a:ln w="0">
            <a:noFill/>
          </a:ln>
        </p:spPr>
      </p:pic>
      <p:sp>
        <p:nvSpPr>
          <p:cNvPr id="184" name="Rectangle 19"/>
          <p:cNvSpPr/>
          <p:nvPr/>
        </p:nvSpPr>
        <p:spPr>
          <a:xfrm>
            <a:off x="8183520" y="4329000"/>
            <a:ext cx="2311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white Dahomey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tock 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5" name="Picture 31" descr=""/>
          <p:cNvPicPr/>
          <p:nvPr/>
        </p:nvPicPr>
        <p:blipFill>
          <a:blip r:embed="rId4"/>
          <a:stretch/>
        </p:blipFill>
        <p:spPr>
          <a:xfrm>
            <a:off x="5351400" y="4417920"/>
            <a:ext cx="1057320" cy="554040"/>
          </a:xfrm>
          <a:prstGeom prst="rect">
            <a:avLst/>
          </a:prstGeom>
          <a:ln w="0">
            <a:noFill/>
          </a:ln>
        </p:spPr>
      </p:pic>
      <p:sp>
        <p:nvSpPr>
          <p:cNvPr id="186" name="Rectangle 38"/>
          <p:cNvSpPr/>
          <p:nvPr/>
        </p:nvSpPr>
        <p:spPr>
          <a:xfrm>
            <a:off x="4782240" y="45115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Box 47"/>
          <p:cNvSpPr/>
          <p:nvPr/>
        </p:nvSpPr>
        <p:spPr>
          <a:xfrm>
            <a:off x="6526080" y="4403880"/>
            <a:ext cx="947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r>
              <a:rPr b="0" lang="en-US" sz="1200" spc="-1" strike="noStrike" u="sng" baseline="30000">
                <a:solidFill>
                  <a:srgbClr val="000000"/>
                </a:solidFill>
                <a:uFillTx/>
                <a:latin typeface="Arial"/>
              </a:rPr>
              <a:t>Dahome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ight Brace 44"/>
          <p:cNvSpPr/>
          <p:nvPr/>
        </p:nvSpPr>
        <p:spPr>
          <a:xfrm>
            <a:off x="7621560" y="4330800"/>
            <a:ext cx="530280" cy="7286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728640"/>
              <a:gd name="textAreaBottom" fmla="*/ 714960 h 728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55"/>
                  <a:pt x="10800" y="1310"/>
                </a:cubicBezTo>
                <a:lnTo>
                  <a:pt x="10800" y="9490"/>
                </a:lnTo>
                <a:cubicBezTo>
                  <a:pt x="10800" y="10145"/>
                  <a:pt x="16200" y="10800"/>
                  <a:pt x="21600" y="10800"/>
                </a:cubicBezTo>
                <a:cubicBezTo>
                  <a:pt x="16200" y="10800"/>
                  <a:pt x="10800" y="11455"/>
                  <a:pt x="10800" y="12110"/>
                </a:cubicBezTo>
                <a:lnTo>
                  <a:pt x="10800" y="20290"/>
                </a:lnTo>
                <a:cubicBezTo>
                  <a:pt x="10800" y="2094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9" name="Picture 6" descr=""/>
          <p:cNvPicPr/>
          <p:nvPr/>
        </p:nvPicPr>
        <p:blipFill>
          <a:blip r:embed="rId5"/>
          <a:stretch/>
        </p:blipFill>
        <p:spPr>
          <a:xfrm>
            <a:off x="3463920" y="5667480"/>
            <a:ext cx="1063800" cy="649080"/>
          </a:xfrm>
          <a:prstGeom prst="rect">
            <a:avLst/>
          </a:prstGeom>
          <a:ln w="0">
            <a:noFill/>
          </a:ln>
        </p:spPr>
      </p:pic>
      <p:cxnSp>
        <p:nvCxnSpPr>
          <p:cNvPr id="190" name="Straight Arrow Connector 46"/>
          <p:cNvCxnSpPr/>
          <p:nvPr/>
        </p:nvCxnSpPr>
        <p:spPr>
          <a:xfrm flipH="1">
            <a:off x="4236480" y="5075280"/>
            <a:ext cx="548280" cy="4737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191" name="Rectangle 46"/>
          <p:cNvSpPr/>
          <p:nvPr/>
        </p:nvSpPr>
        <p:spPr>
          <a:xfrm>
            <a:off x="2136600" y="5762520"/>
            <a:ext cx="1489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Box 39"/>
          <p:cNvSpPr/>
          <p:nvPr/>
        </p:nvSpPr>
        <p:spPr>
          <a:xfrm>
            <a:off x="831960" y="5730840"/>
            <a:ext cx="1512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terozygot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 offspr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, S2, S3 or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3" name="Picture 4" descr=""/>
          <p:cNvPicPr/>
          <p:nvPr/>
        </p:nvPicPr>
        <p:blipFill>
          <a:blip r:embed="rId6"/>
          <a:stretch/>
        </p:blipFill>
        <p:spPr>
          <a:xfrm>
            <a:off x="5351400" y="5664240"/>
            <a:ext cx="1060560" cy="550800"/>
          </a:xfrm>
          <a:prstGeom prst="rect">
            <a:avLst/>
          </a:prstGeom>
          <a:ln w="0">
            <a:noFill/>
          </a:ln>
        </p:spPr>
      </p:pic>
      <p:sp>
        <p:nvSpPr>
          <p:cNvPr id="194" name="Rectangle 35"/>
          <p:cNvSpPr/>
          <p:nvPr/>
        </p:nvSpPr>
        <p:spPr>
          <a:xfrm>
            <a:off x="6496560" y="5708520"/>
            <a:ext cx="1157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Rectangle 36"/>
          <p:cNvSpPr/>
          <p:nvPr/>
        </p:nvSpPr>
        <p:spPr>
          <a:xfrm>
            <a:off x="4785480" y="57513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Rectangle 19"/>
          <p:cNvSpPr/>
          <p:nvPr/>
        </p:nvSpPr>
        <p:spPr>
          <a:xfrm>
            <a:off x="8183520" y="5570640"/>
            <a:ext cx="23115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males from same evolved line </a:t>
            </a:r>
            <a:br>
              <a:rPr sz="1400"/>
            </a:b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(S1, S2, S3 or S4)</a:t>
            </a:r>
            <a:br>
              <a:rPr sz="1400"/>
            </a:b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repeated x 6 genera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Right Brace 54"/>
          <p:cNvSpPr/>
          <p:nvPr/>
        </p:nvSpPr>
        <p:spPr>
          <a:xfrm>
            <a:off x="7621560" y="5572080"/>
            <a:ext cx="530280" cy="7286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728640"/>
              <a:gd name="textAreaBottom" fmla="*/ 714960 h 728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55"/>
                  <a:pt x="10800" y="1310"/>
                </a:cubicBezTo>
                <a:lnTo>
                  <a:pt x="10800" y="9490"/>
                </a:lnTo>
                <a:cubicBezTo>
                  <a:pt x="10800" y="10145"/>
                  <a:pt x="16200" y="10800"/>
                  <a:pt x="21600" y="10800"/>
                </a:cubicBezTo>
                <a:cubicBezTo>
                  <a:pt x="16200" y="10800"/>
                  <a:pt x="10800" y="11455"/>
                  <a:pt x="10800" y="12110"/>
                </a:cubicBezTo>
                <a:lnTo>
                  <a:pt x="10800" y="20290"/>
                </a:lnTo>
                <a:cubicBezTo>
                  <a:pt x="10800" y="2094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Rectangle 46"/>
          <p:cNvSpPr/>
          <p:nvPr/>
        </p:nvSpPr>
        <p:spPr>
          <a:xfrm>
            <a:off x="2184480" y="4452840"/>
            <a:ext cx="148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Box 39"/>
          <p:cNvSpPr/>
          <p:nvPr/>
        </p:nvSpPr>
        <p:spPr>
          <a:xfrm>
            <a:off x="879840" y="4421160"/>
            <a:ext cx="1035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, S2,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 S4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0" name="Picture 6" descr=""/>
          <p:cNvPicPr/>
          <p:nvPr/>
        </p:nvPicPr>
        <p:blipFill>
          <a:blip r:embed="rId7"/>
          <a:stretch/>
        </p:blipFill>
        <p:spPr>
          <a:xfrm>
            <a:off x="3460680" y="6902280"/>
            <a:ext cx="1063800" cy="649440"/>
          </a:xfrm>
          <a:prstGeom prst="rect">
            <a:avLst/>
          </a:prstGeom>
          <a:ln w="0">
            <a:noFill/>
          </a:ln>
        </p:spPr>
      </p:pic>
      <p:pic>
        <p:nvPicPr>
          <p:cNvPr id="201" name="Picture 58" descr=""/>
          <p:cNvPicPr/>
          <p:nvPr/>
        </p:nvPicPr>
        <p:blipFill>
          <a:blip r:embed="rId8"/>
          <a:stretch/>
        </p:blipFill>
        <p:spPr>
          <a:xfrm>
            <a:off x="5353200" y="6913440"/>
            <a:ext cx="1055520" cy="554040"/>
          </a:xfrm>
          <a:prstGeom prst="rect">
            <a:avLst/>
          </a:prstGeom>
          <a:ln w="0">
            <a:noFill/>
          </a:ln>
        </p:spPr>
      </p:pic>
      <p:cxnSp>
        <p:nvCxnSpPr>
          <p:cNvPr id="202" name="Straight Arrow Connector 59"/>
          <p:cNvCxnSpPr/>
          <p:nvPr/>
        </p:nvCxnSpPr>
        <p:spPr>
          <a:xfrm flipH="1">
            <a:off x="4231800" y="6191280"/>
            <a:ext cx="548640" cy="475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203" name="Rectangle 43"/>
          <p:cNvSpPr/>
          <p:nvPr/>
        </p:nvSpPr>
        <p:spPr>
          <a:xfrm>
            <a:off x="4820400" y="70977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x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4" name="Straight Arrow Connector 62"/>
          <p:cNvCxnSpPr/>
          <p:nvPr/>
        </p:nvCxnSpPr>
        <p:spPr>
          <a:xfrm>
            <a:off x="5060880" y="6183360"/>
            <a:ext cx="548640" cy="475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205" name="TextBox 49"/>
          <p:cNvSpPr/>
          <p:nvPr/>
        </p:nvSpPr>
        <p:spPr>
          <a:xfrm>
            <a:off x="6772320" y="701676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ight Brace 65"/>
          <p:cNvSpPr/>
          <p:nvPr/>
        </p:nvSpPr>
        <p:spPr>
          <a:xfrm>
            <a:off x="7651800" y="6943680"/>
            <a:ext cx="530280" cy="6080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608040"/>
              <a:gd name="textAreaBottom" fmla="*/ 594360 h 6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85"/>
                  <a:pt x="10800" y="1570"/>
                </a:cubicBezTo>
                <a:lnTo>
                  <a:pt x="10800" y="9230"/>
                </a:lnTo>
                <a:cubicBezTo>
                  <a:pt x="10800" y="10015"/>
                  <a:pt x="16200" y="10800"/>
                  <a:pt x="21600" y="10800"/>
                </a:cubicBezTo>
                <a:cubicBezTo>
                  <a:pt x="16200" y="10800"/>
                  <a:pt x="10800" y="11585"/>
                  <a:pt x="10800" y="12370"/>
                </a:cubicBezTo>
                <a:lnTo>
                  <a:pt x="10800" y="20030"/>
                </a:lnTo>
                <a:cubicBezTo>
                  <a:pt x="10800" y="2081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Rectangle 50"/>
          <p:cNvSpPr/>
          <p:nvPr/>
        </p:nvSpPr>
        <p:spPr>
          <a:xfrm>
            <a:off x="8317080" y="6943680"/>
            <a:ext cx="20541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cross to white male offspring from same line and cros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69"/>
          <p:cNvSpPr/>
          <p:nvPr/>
        </p:nvSpPr>
        <p:spPr>
          <a:xfrm>
            <a:off x="2136600" y="7077240"/>
            <a:ext cx="1489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pl-PL" sz="1200" spc="-1" strike="noStrike" u="sng">
                <a:solidFill>
                  <a:srgbClr val="000000"/>
                </a:solidFill>
                <a:uFillTx/>
                <a:latin typeface="Arial"/>
              </a:rPr>
              <a:t>Df(1)Exel623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TextBox 39"/>
          <p:cNvSpPr/>
          <p:nvPr/>
        </p:nvSpPr>
        <p:spPr>
          <a:xfrm>
            <a:off x="831960" y="6867360"/>
            <a:ext cx="151272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terozygote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male offspr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, S2, S3 or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10" name="Straight Arrow Connector 70"/>
          <p:cNvCxnSpPr/>
          <p:nvPr/>
        </p:nvCxnSpPr>
        <p:spPr>
          <a:xfrm flipH="1">
            <a:off x="4244400" y="7467120"/>
            <a:ext cx="54828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211" name="Straight Arrow Connector 71"/>
          <p:cNvCxnSpPr/>
          <p:nvPr/>
        </p:nvCxnSpPr>
        <p:spPr>
          <a:xfrm>
            <a:off x="5073480" y="7459200"/>
            <a:ext cx="54864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pic>
        <p:nvPicPr>
          <p:cNvPr id="212" name="Picture 30" descr=""/>
          <p:cNvPicPr/>
          <p:nvPr/>
        </p:nvPicPr>
        <p:blipFill>
          <a:blip r:embed="rId9"/>
          <a:stretch/>
        </p:blipFill>
        <p:spPr>
          <a:xfrm>
            <a:off x="3544920" y="8231040"/>
            <a:ext cx="1054080" cy="63504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73" descr=""/>
          <p:cNvPicPr/>
          <p:nvPr/>
        </p:nvPicPr>
        <p:blipFill>
          <a:blip r:embed="rId10"/>
          <a:stretch/>
        </p:blipFill>
        <p:spPr>
          <a:xfrm>
            <a:off x="5353200" y="8231040"/>
            <a:ext cx="1055520" cy="554040"/>
          </a:xfrm>
          <a:prstGeom prst="rect">
            <a:avLst/>
          </a:prstGeom>
          <a:ln w="0">
            <a:noFill/>
          </a:ln>
        </p:spPr>
      </p:pic>
      <p:sp>
        <p:nvSpPr>
          <p:cNvPr id="214" name="TextBox 34"/>
          <p:cNvSpPr/>
          <p:nvPr/>
        </p:nvSpPr>
        <p:spPr>
          <a:xfrm>
            <a:off x="2600280" y="826452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TextBox 47"/>
          <p:cNvSpPr/>
          <p:nvPr/>
        </p:nvSpPr>
        <p:spPr>
          <a:xfrm>
            <a:off x="6789960" y="825012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ight Brace 76"/>
          <p:cNvSpPr/>
          <p:nvPr/>
        </p:nvSpPr>
        <p:spPr>
          <a:xfrm>
            <a:off x="7642080" y="8177040"/>
            <a:ext cx="530280" cy="608040"/>
          </a:xfrm>
          <a:custGeom>
            <a:avLst/>
            <a:gdLst>
              <a:gd name="textAreaLeft" fmla="*/ 0 w 530280"/>
              <a:gd name="textAreaRight" fmla="*/ 191520 w 530280"/>
              <a:gd name="textAreaTop" fmla="*/ 13680 h 608040"/>
              <a:gd name="textAreaBottom" fmla="*/ 594360 h 6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85"/>
                  <a:pt x="10800" y="1570"/>
                </a:cubicBezTo>
                <a:lnTo>
                  <a:pt x="10800" y="9230"/>
                </a:lnTo>
                <a:cubicBezTo>
                  <a:pt x="10800" y="10015"/>
                  <a:pt x="16200" y="10800"/>
                  <a:pt x="21600" y="10800"/>
                </a:cubicBezTo>
                <a:cubicBezTo>
                  <a:pt x="16200" y="10800"/>
                  <a:pt x="10800" y="11585"/>
                  <a:pt x="10800" y="12370"/>
                </a:cubicBezTo>
                <a:lnTo>
                  <a:pt x="10800" y="20030"/>
                </a:lnTo>
                <a:cubicBezTo>
                  <a:pt x="10800" y="20815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Rectangle 50"/>
          <p:cNvSpPr/>
          <p:nvPr/>
        </p:nvSpPr>
        <p:spPr>
          <a:xfrm>
            <a:off x="8292960" y="8096400"/>
            <a:ext cx="20545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white-eyed flies in</a:t>
            </a:r>
            <a:br>
              <a:rPr sz="1400"/>
            </a:b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PR- evolved genetic backgroun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18" name="Straight Arrow Connector 79"/>
          <p:cNvCxnSpPr/>
          <p:nvPr/>
        </p:nvCxnSpPr>
        <p:spPr>
          <a:xfrm>
            <a:off x="4282560" y="8818200"/>
            <a:ext cx="3960" cy="4309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cxnSp>
        <p:nvCxnSpPr>
          <p:cNvPr id="219" name="Straight Arrow Connector 80"/>
          <p:cNvCxnSpPr/>
          <p:nvPr/>
        </p:nvCxnSpPr>
        <p:spPr>
          <a:xfrm>
            <a:off x="5643720" y="8791200"/>
            <a:ext cx="2160" cy="4309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pic>
        <p:nvPicPr>
          <p:cNvPr id="220" name="Picture 53" descr=""/>
          <p:cNvPicPr/>
          <p:nvPr/>
        </p:nvPicPr>
        <p:blipFill>
          <a:blip r:embed="rId11"/>
          <a:stretch/>
        </p:blipFill>
        <p:spPr>
          <a:xfrm>
            <a:off x="4411800" y="9460080"/>
            <a:ext cx="1054080" cy="634680"/>
          </a:xfrm>
          <a:prstGeom prst="rect">
            <a:avLst/>
          </a:prstGeom>
          <a:ln w="0">
            <a:noFill/>
          </a:ln>
        </p:spPr>
      </p:pic>
      <p:pic>
        <p:nvPicPr>
          <p:cNvPr id="221" name="Picture 61" descr=""/>
          <p:cNvPicPr/>
          <p:nvPr/>
        </p:nvPicPr>
        <p:blipFill>
          <a:blip r:embed="rId12"/>
          <a:stretch/>
        </p:blipFill>
        <p:spPr>
          <a:xfrm>
            <a:off x="4410000" y="10045800"/>
            <a:ext cx="1055880" cy="554040"/>
          </a:xfrm>
          <a:prstGeom prst="rect">
            <a:avLst/>
          </a:prstGeom>
          <a:ln w="0">
            <a:noFill/>
          </a:ln>
        </p:spPr>
      </p:pic>
      <p:sp>
        <p:nvSpPr>
          <p:cNvPr id="222" name="Rectangle 83"/>
          <p:cNvSpPr/>
          <p:nvPr/>
        </p:nvSpPr>
        <p:spPr>
          <a:xfrm>
            <a:off x="4245120" y="9290160"/>
            <a:ext cx="1450800" cy="1447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TextBox 74"/>
          <p:cNvSpPr/>
          <p:nvPr/>
        </p:nvSpPr>
        <p:spPr>
          <a:xfrm>
            <a:off x="5771520" y="942984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Box 75"/>
          <p:cNvSpPr/>
          <p:nvPr/>
        </p:nvSpPr>
        <p:spPr>
          <a:xfrm>
            <a:off x="5771520" y="9964800"/>
            <a:ext cx="570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Wh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TextBox 83"/>
          <p:cNvSpPr/>
          <p:nvPr/>
        </p:nvSpPr>
        <p:spPr>
          <a:xfrm>
            <a:off x="4082040" y="10806120"/>
            <a:ext cx="18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1     S2     S3    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Box 77"/>
          <p:cNvSpPr/>
          <p:nvPr/>
        </p:nvSpPr>
        <p:spPr>
          <a:xfrm>
            <a:off x="6357960" y="945036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TextBox 78"/>
          <p:cNvSpPr/>
          <p:nvPr/>
        </p:nvSpPr>
        <p:spPr>
          <a:xfrm>
            <a:off x="6356520" y="9983880"/>
            <a:ext cx="5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Right Brace 89"/>
          <p:cNvSpPr/>
          <p:nvPr/>
        </p:nvSpPr>
        <p:spPr>
          <a:xfrm>
            <a:off x="6942240" y="9075600"/>
            <a:ext cx="531720" cy="1632240"/>
          </a:xfrm>
          <a:custGeom>
            <a:avLst/>
            <a:gdLst>
              <a:gd name="textAreaLeft" fmla="*/ 0 w 531720"/>
              <a:gd name="textAreaRight" fmla="*/ 191880 w 531720"/>
              <a:gd name="textAreaTop" fmla="*/ 13680 h 1632240"/>
              <a:gd name="textAreaBottom" fmla="*/ 1618560 h 1632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94"/>
                  <a:pt x="10800" y="587"/>
                </a:cubicBezTo>
                <a:lnTo>
                  <a:pt x="10800" y="10213"/>
                </a:lnTo>
                <a:cubicBezTo>
                  <a:pt x="10800" y="10507"/>
                  <a:pt x="16200" y="10800"/>
                  <a:pt x="21600" y="10800"/>
                </a:cubicBezTo>
                <a:cubicBezTo>
                  <a:pt x="16200" y="10800"/>
                  <a:pt x="10800" y="11094"/>
                  <a:pt x="10800" y="11387"/>
                </a:cubicBezTo>
                <a:lnTo>
                  <a:pt x="10800" y="21013"/>
                </a:lnTo>
                <a:cubicBezTo>
                  <a:pt x="10800" y="21307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Rectangle 50"/>
          <p:cNvSpPr/>
          <p:nvPr/>
        </p:nvSpPr>
        <p:spPr>
          <a:xfrm>
            <a:off x="7520040" y="9572760"/>
            <a:ext cx="20541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”</a:t>
            </a: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PR- evolved control” populations (white eyed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30" name="Straight Arrow Connector 91"/>
          <p:cNvCxnSpPr/>
          <p:nvPr/>
        </p:nvCxnSpPr>
        <p:spPr>
          <a:xfrm flipH="1">
            <a:off x="4357080" y="3863520"/>
            <a:ext cx="548280" cy="475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lg" type="triangle" w="lg"/>
          </a:ln>
        </p:spPr>
      </p:cxnSp>
      <p:sp>
        <p:nvSpPr>
          <p:cNvPr id="231" name="Right Brace 93"/>
          <p:cNvSpPr/>
          <p:nvPr/>
        </p:nvSpPr>
        <p:spPr>
          <a:xfrm>
            <a:off x="7574040" y="2209680"/>
            <a:ext cx="531720" cy="1632240"/>
          </a:xfrm>
          <a:custGeom>
            <a:avLst/>
            <a:gdLst>
              <a:gd name="textAreaLeft" fmla="*/ 0 w 531720"/>
              <a:gd name="textAreaRight" fmla="*/ 191880 w 531720"/>
              <a:gd name="textAreaTop" fmla="*/ 13680 h 1632240"/>
              <a:gd name="textAreaBottom" fmla="*/ 1618560 h 1632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94"/>
                  <a:pt x="10800" y="587"/>
                </a:cubicBezTo>
                <a:lnTo>
                  <a:pt x="10800" y="10213"/>
                </a:lnTo>
                <a:cubicBezTo>
                  <a:pt x="10800" y="10507"/>
                  <a:pt x="16200" y="10800"/>
                  <a:pt x="21600" y="10800"/>
                </a:cubicBezTo>
                <a:cubicBezTo>
                  <a:pt x="16200" y="10800"/>
                  <a:pt x="10800" y="11094"/>
                  <a:pt x="10800" y="11387"/>
                </a:cubicBezTo>
                <a:lnTo>
                  <a:pt x="10800" y="21013"/>
                </a:lnTo>
                <a:cubicBezTo>
                  <a:pt x="10800" y="21307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Rectangle 50"/>
          <p:cNvSpPr/>
          <p:nvPr/>
        </p:nvSpPr>
        <p:spPr>
          <a:xfrm>
            <a:off x="8151840" y="2706840"/>
            <a:ext cx="2054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SPR- evolved populations (red eyes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TextBox 95"/>
          <p:cNvSpPr/>
          <p:nvPr/>
        </p:nvSpPr>
        <p:spPr>
          <a:xfrm>
            <a:off x="499680" y="399960"/>
            <a:ext cx="115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6T13:00:52Z</dcterms:created>
  <dc:creator>Stuart Wigby</dc:creator>
  <dc:description/>
  <dc:language>en-US</dc:language>
  <cp:lastModifiedBy>jcp</cp:lastModifiedBy>
  <dcterms:modified xsi:type="dcterms:W3CDTF">2016-05-05T15:41:07Z</dcterms:modified>
  <cp:revision>115</cp:revision>
  <dc:subject/>
  <dc:title>PowerPoint Presentation</dc:title>
</cp:coreProperties>
</file>